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75" d="100"/>
          <a:sy n="75" d="100"/>
        </p:scale>
        <p:origin x="-1560" y="85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29E74-21DF-43F6-BC01-7DAF85C77957}" type="datetimeFigureOut">
              <a:rPr lang="en-US" smtClean="0"/>
              <a:pPr/>
              <a:t>7/6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D784E-C0AA-40DC-A184-6CFCC97D291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22860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7200" y="5488156"/>
            <a:ext cx="5943600" cy="2970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S1.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Potential enhancement of anti-tumor immune responses by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Nr-CWS. 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A)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Representative images of subcutaneous tumors dissected from Nr-CWS treated mice and control mice at day 7 and 14.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B, C)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Representative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mages of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histopathological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features of subcutaneous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tumors.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umors were confirmed by H&amp;E staining. Larger patchy 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necrosis (white circle in panel B, 200×)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 and more discernible infiltration of inflammatory cells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white arrow in panel C, 400×) were observed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n the sections from Nr-CWS treated mice than that from control mice (after 14 days treatment).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D)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Representative images (400×) and analyses of apoptotic cells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white arrow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 in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umor tissues by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TUNEL.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More TUNEL-positive cells were observed in Nr-CWS treated mice than that in control mice (after 14 days treatment)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E)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umor infiltrating lymphocytes were analyzed by FCM. The CD3</a:t>
            </a:r>
            <a:r>
              <a:rPr lang="en-US" sz="11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CD4</a:t>
            </a:r>
            <a:r>
              <a:rPr lang="en-US" sz="11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T, CD8</a:t>
            </a:r>
            <a:r>
              <a:rPr lang="en-US" sz="11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T, and NK cells were gated as shown in the contour plot, based on CD4, CD3ε, CD8α, and NK1.1 staining and gated on viable cells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Representative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flow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graphs were shown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F)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Representative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mages of metastases from mice treated with or without Nr-CWS at day 14 after tail vein injection of B16F10 melanoma cells (0.2 M/mous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G)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he purification of NK cells by MACS. The purity of NK cell reached to 81.7% post purification, while it was about 2.5% before purification in spleen. Data shown are representative of at least three independent experiment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37100\Desktop\Revised Figures\Revised Figure S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9600" y="736116"/>
            <a:ext cx="5486400" cy="467408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22860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7200" y="3176081"/>
            <a:ext cx="59436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S2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Expression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of functional molecules of NK cells after Nr-CWS treatment </a:t>
            </a:r>
            <a:r>
              <a:rPr lang="en-US" sz="1100" b="1" i="1" dirty="0">
                <a:latin typeface="Arial" pitchFamily="34" charset="0"/>
                <a:cs typeface="Arial" pitchFamily="34" charset="0"/>
              </a:rPr>
              <a:t>in vivo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100" b="1" i="1" dirty="0">
                <a:latin typeface="Arial" pitchFamily="34" charset="0"/>
                <a:cs typeface="Arial" pitchFamily="34" charset="0"/>
              </a:rPr>
              <a:t>in vitro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. (A-C)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Representative histogram of flow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showed the expression of CD69, TRAIL, and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FasL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on viable NK cells </a:t>
            </a:r>
            <a:r>
              <a:rPr lang="en-US" sz="1100" i="1" dirty="0">
                <a:latin typeface="Arial" pitchFamily="34" charset="0"/>
                <a:cs typeface="Arial" pitchFamily="34" charset="0"/>
              </a:rPr>
              <a:t>in vivo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(A)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100" i="1" dirty="0">
                <a:latin typeface="Arial" pitchFamily="34" charset="0"/>
                <a:cs typeface="Arial" pitchFamily="34" charset="0"/>
              </a:rPr>
              <a:t>in vitro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24 hrs;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48 hr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 descr="C:\Users\37100\Desktop\Revised Figures\Revised Figure S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5800" y="603446"/>
            <a:ext cx="5486400" cy="2520754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52400" y="421359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7200" y="8171527"/>
            <a:ext cx="59436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S3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nalysis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of NK cell subgroups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nd the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xpression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of </a:t>
            </a:r>
            <a:r>
              <a:rPr lang="en-US" sz="1100" b="1" dirty="0" err="1">
                <a:latin typeface="Arial" pitchFamily="34" charset="0"/>
                <a:cs typeface="Arial" pitchFamily="34" charset="0"/>
              </a:rPr>
              <a:t>perforin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100" b="1" dirty="0" err="1">
                <a:latin typeface="Arial" pitchFamily="34" charset="0"/>
                <a:cs typeface="Arial" pitchFamily="34" charset="0"/>
              </a:rPr>
              <a:t>granzyme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en-US" sz="1100" b="1" i="1" dirty="0" smtClean="0">
                <a:latin typeface="Arial" pitchFamily="34" charset="0"/>
                <a:cs typeface="Arial" pitchFamily="34" charset="0"/>
              </a:rPr>
              <a:t>in </a:t>
            </a:r>
            <a:r>
              <a:rPr lang="en-US" sz="1100" b="1" i="1" dirty="0">
                <a:latin typeface="Arial" pitchFamily="34" charset="0"/>
                <a:cs typeface="Arial" pitchFamily="34" charset="0"/>
              </a:rPr>
              <a:t>vitro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. (A, B)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Representative graphs of flow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showed the percentage of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Prf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GrzB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24 hrs;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48 hrs)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D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he contour plot showed the quadrant gate of NK cell subgroups by the expression of CD11b and CD27. Representative images of the Nr-CWS treated and control NK cells were shown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24 hrs;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D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48 hr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2" descr="C:\Users\37100\Desktop\Revised Figures\Revised Figure S3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24000" y="4594592"/>
            <a:ext cx="3657600" cy="354774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22860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4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7200" y="2590800"/>
            <a:ext cx="59436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S4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nalysis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of cytokines. (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, B)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Representative flow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graphs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of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he expression of IFN-γ and TNF-α of NK cells treated with or without Nr-CWS. Histograms of flow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of Nr-CWS treated NK cells (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24 hrs;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48 hrs). </a:t>
            </a:r>
          </a:p>
        </p:txBody>
      </p:sp>
      <p:pic>
        <p:nvPicPr>
          <p:cNvPr id="4098" name="Picture 2" descr="C:\Users\37100\Desktop\Revised Figures\Revised Figure S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95400" y="762000"/>
            <a:ext cx="3200400" cy="171146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270</Words>
  <Application>Microsoft Office PowerPoint</Application>
  <PresentationFormat>A4 纸张(210x297 毫米)</PresentationFormat>
  <Paragraphs>8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avid</dc:creator>
  <cp:lastModifiedBy>David</cp:lastModifiedBy>
  <cp:revision>7</cp:revision>
  <dcterms:created xsi:type="dcterms:W3CDTF">2022-07-06T03:15:20Z</dcterms:created>
  <dcterms:modified xsi:type="dcterms:W3CDTF">2022-07-06T06:45:52Z</dcterms:modified>
</cp:coreProperties>
</file>